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E179C-CD60-425D-9BC3-A0AD7A5C77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3D893-04D5-4D0E-8A77-DEFF4C4A6C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F0E88-BB4B-45B3-B722-22DABABEEC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928E6-021B-410F-8D24-7F242E28AF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76F1E-9BA8-4654-AA6D-FF42418211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72DB1-7A39-4D14-A45A-B3BAB9C0D7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64F39-1076-4A3B-874E-914F8221A7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31D73-19B4-4C17-9A9B-C70A17D40A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D57A8-23DB-43D6-BB50-05F211209E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C82724-64A9-4658-A1C0-0A74EDCF8E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3CEA9F-A048-4ADE-89C4-B29D8B4A0F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E290DD-096A-4621-B51E-927EEE4530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3EACD6-0E1C-4D4A-98B3-D72AE42B711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"/>
          <p:cNvSpPr/>
          <p:nvPr/>
        </p:nvSpPr>
        <p:spPr>
          <a:xfrm>
            <a:off x="2067480" y="190440"/>
            <a:ext cx="4431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1. Kashiwagi S. et al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71"/>
          <p:cNvSpPr/>
          <p:nvPr/>
        </p:nvSpPr>
        <p:spPr>
          <a:xfrm>
            <a:off x="1482840" y="1606680"/>
            <a:ext cx="174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ge I (n=59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127"/>
          <p:cNvSpPr/>
          <p:nvPr/>
        </p:nvSpPr>
        <p:spPr>
          <a:xfrm>
            <a:off x="4063320" y="1995480"/>
            <a:ext cx="83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=0.393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84"/>
          <p:cNvSpPr/>
          <p:nvPr/>
        </p:nvSpPr>
        <p:spPr>
          <a:xfrm>
            <a:off x="3998160" y="3879720"/>
            <a:ext cx="1395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Years after surg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85"/>
          <p:cNvSpPr/>
          <p:nvPr/>
        </p:nvSpPr>
        <p:spPr>
          <a:xfrm>
            <a:off x="5814360" y="3719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86"/>
          <p:cNvSpPr/>
          <p:nvPr/>
        </p:nvSpPr>
        <p:spPr>
          <a:xfrm>
            <a:off x="5436360" y="3719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87"/>
          <p:cNvSpPr/>
          <p:nvPr/>
        </p:nvSpPr>
        <p:spPr>
          <a:xfrm>
            <a:off x="5047560" y="3719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88"/>
          <p:cNvSpPr/>
          <p:nvPr/>
        </p:nvSpPr>
        <p:spPr>
          <a:xfrm>
            <a:off x="4660200" y="3719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89"/>
          <p:cNvSpPr/>
          <p:nvPr/>
        </p:nvSpPr>
        <p:spPr>
          <a:xfrm>
            <a:off x="4280760" y="3719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90"/>
          <p:cNvSpPr/>
          <p:nvPr/>
        </p:nvSpPr>
        <p:spPr>
          <a:xfrm>
            <a:off x="3886920" y="3719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91"/>
          <p:cNvSpPr/>
          <p:nvPr/>
        </p:nvSpPr>
        <p:spPr>
          <a:xfrm>
            <a:off x="3452040" y="3719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92"/>
          <p:cNvSpPr/>
          <p:nvPr/>
        </p:nvSpPr>
        <p:spPr>
          <a:xfrm rot="16200000">
            <a:off x="2467080" y="2672640"/>
            <a:ext cx="1595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verall survival 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93"/>
          <p:cNvSpPr/>
          <p:nvPr/>
        </p:nvSpPr>
        <p:spPr>
          <a:xfrm>
            <a:off x="3305160" y="17668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94"/>
          <p:cNvSpPr/>
          <p:nvPr/>
        </p:nvSpPr>
        <p:spPr>
          <a:xfrm>
            <a:off x="3391560" y="21178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95"/>
          <p:cNvSpPr/>
          <p:nvPr/>
        </p:nvSpPr>
        <p:spPr>
          <a:xfrm>
            <a:off x="3396600" y="248760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96"/>
          <p:cNvSpPr/>
          <p:nvPr/>
        </p:nvSpPr>
        <p:spPr>
          <a:xfrm>
            <a:off x="3386880" y="286560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97"/>
          <p:cNvSpPr/>
          <p:nvPr/>
        </p:nvSpPr>
        <p:spPr>
          <a:xfrm>
            <a:off x="3391560" y="32338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106"/>
          <p:cNvSpPr/>
          <p:nvPr/>
        </p:nvSpPr>
        <p:spPr>
          <a:xfrm>
            <a:off x="3556080" y="3683160"/>
            <a:ext cx="2298600" cy="12600"/>
          </a:xfrm>
          <a:custGeom>
            <a:avLst/>
            <a:gdLst>
              <a:gd name="textAreaLeft" fmla="*/ 0 w 2298600"/>
              <a:gd name="textAreaRight" fmla="*/ 2298960 w 229860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1400" h="8">
                <a:moveTo>
                  <a:pt x="1400" y="0"/>
                </a:moveTo>
                <a:lnTo>
                  <a:pt x="1400" y="8"/>
                </a:lnTo>
                <a:moveTo>
                  <a:pt x="1168" y="0"/>
                </a:moveTo>
                <a:lnTo>
                  <a:pt x="1168" y="8"/>
                </a:lnTo>
                <a:moveTo>
                  <a:pt x="932" y="0"/>
                </a:moveTo>
                <a:lnTo>
                  <a:pt x="932" y="8"/>
                </a:lnTo>
                <a:moveTo>
                  <a:pt x="700" y="0"/>
                </a:moveTo>
                <a:lnTo>
                  <a:pt x="700" y="8"/>
                </a:lnTo>
                <a:moveTo>
                  <a:pt x="468" y="0"/>
                </a:moveTo>
                <a:lnTo>
                  <a:pt x="468" y="8"/>
                </a:lnTo>
                <a:moveTo>
                  <a:pt x="232" y="0"/>
                </a:moveTo>
                <a:lnTo>
                  <a:pt x="232" y="8"/>
                </a:lnTo>
                <a:moveTo>
                  <a:pt x="0" y="0"/>
                </a:moveTo>
                <a:lnTo>
                  <a:pt x="0" y="8"/>
                </a:ln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Freeform 107"/>
          <p:cNvSpPr/>
          <p:nvPr/>
        </p:nvSpPr>
        <p:spPr>
          <a:xfrm>
            <a:off x="3532320" y="1849320"/>
            <a:ext cx="23760" cy="1827360"/>
          </a:xfrm>
          <a:custGeom>
            <a:avLst/>
            <a:gdLst>
              <a:gd name="textAreaLeft" fmla="*/ 0 w 23760"/>
              <a:gd name="textAreaRight" fmla="*/ 24120 w 23760"/>
              <a:gd name="textAreaTop" fmla="*/ 0 h 1827360"/>
              <a:gd name="textAreaBottom" fmla="*/ 1827720 h 1827360"/>
            </a:gdLst>
            <a:ahLst/>
            <a:rect l="textAreaLeft" t="textAreaTop" r="textAreaRight" b="textAreaBottom"/>
            <a:pathLst>
              <a:path w="13" h="1205">
                <a:moveTo>
                  <a:pt x="0" y="0"/>
                </a:moveTo>
                <a:lnTo>
                  <a:pt x="13" y="0"/>
                </a:lnTo>
                <a:moveTo>
                  <a:pt x="0" y="240"/>
                </a:moveTo>
                <a:lnTo>
                  <a:pt x="13" y="240"/>
                </a:lnTo>
                <a:moveTo>
                  <a:pt x="0" y="480"/>
                </a:moveTo>
                <a:lnTo>
                  <a:pt x="13" y="480"/>
                </a:lnTo>
                <a:moveTo>
                  <a:pt x="0" y="725"/>
                </a:moveTo>
                <a:lnTo>
                  <a:pt x="13" y="725"/>
                </a:lnTo>
                <a:moveTo>
                  <a:pt x="0" y="965"/>
                </a:moveTo>
                <a:lnTo>
                  <a:pt x="13" y="965"/>
                </a:lnTo>
                <a:moveTo>
                  <a:pt x="0" y="1205"/>
                </a:moveTo>
                <a:lnTo>
                  <a:pt x="13" y="1205"/>
                </a:lnTo>
              </a:path>
            </a:pathLst>
          </a:cu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10"/>
          <p:cNvSpPr/>
          <p:nvPr/>
        </p:nvSpPr>
        <p:spPr>
          <a:xfrm>
            <a:off x="3556080" y="3676680"/>
            <a:ext cx="22986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11"/>
          <p:cNvSpPr/>
          <p:nvPr/>
        </p:nvSpPr>
        <p:spPr>
          <a:xfrm flipV="1">
            <a:off x="3556080" y="1849320"/>
            <a:ext cx="0" cy="182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Freeform 159"/>
          <p:cNvSpPr/>
          <p:nvPr/>
        </p:nvSpPr>
        <p:spPr>
          <a:xfrm>
            <a:off x="3592440" y="1854360"/>
            <a:ext cx="1987560" cy="672840"/>
          </a:xfrm>
          <a:custGeom>
            <a:avLst/>
            <a:gdLst>
              <a:gd name="textAreaLeft" fmla="*/ 0 w 1987560"/>
              <a:gd name="textAreaRight" fmla="*/ 1987920 w 1987560"/>
              <a:gd name="textAreaTop" fmla="*/ 0 h 672840"/>
              <a:gd name="textAreaBottom" fmla="*/ 672840 h 672840"/>
            </a:gdLst>
            <a:ahLst/>
            <a:rect l="textAreaLeft" t="textAreaTop" r="textAreaRight" b="textAreaBottom"/>
            <a:pathLst>
              <a:path w="1252" h="424">
                <a:moveTo>
                  <a:pt x="0" y="0"/>
                </a:moveTo>
                <a:lnTo>
                  <a:pt x="384" y="0"/>
                </a:lnTo>
                <a:lnTo>
                  <a:pt x="384" y="84"/>
                </a:lnTo>
                <a:lnTo>
                  <a:pt x="824" y="84"/>
                </a:lnTo>
                <a:lnTo>
                  <a:pt x="824" y="240"/>
                </a:lnTo>
                <a:lnTo>
                  <a:pt x="1012" y="240"/>
                </a:lnTo>
                <a:lnTo>
                  <a:pt x="1012" y="424"/>
                </a:lnTo>
                <a:lnTo>
                  <a:pt x="1252" y="424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160"/>
          <p:cNvSpPr/>
          <p:nvPr/>
        </p:nvSpPr>
        <p:spPr>
          <a:xfrm>
            <a:off x="3592440" y="1854360"/>
            <a:ext cx="1987560" cy="145800"/>
          </a:xfrm>
          <a:custGeom>
            <a:avLst/>
            <a:gdLst>
              <a:gd name="textAreaLeft" fmla="*/ 0 w 1987560"/>
              <a:gd name="textAreaRight" fmla="*/ 1987920 w 1987560"/>
              <a:gd name="textAreaTop" fmla="*/ 0 h 145800"/>
              <a:gd name="textAreaBottom" fmla="*/ 145800 h 145800"/>
            </a:gdLst>
            <a:ahLst/>
            <a:rect l="textAreaLeft" t="textAreaTop" r="textAreaRight" b="textAreaBottom"/>
            <a:pathLst>
              <a:path w="1252" h="92">
                <a:moveTo>
                  <a:pt x="0" y="0"/>
                </a:moveTo>
                <a:lnTo>
                  <a:pt x="0" y="32"/>
                </a:lnTo>
                <a:lnTo>
                  <a:pt x="144" y="32"/>
                </a:lnTo>
                <a:lnTo>
                  <a:pt x="144" y="56"/>
                </a:lnTo>
                <a:lnTo>
                  <a:pt x="416" y="56"/>
                </a:lnTo>
                <a:lnTo>
                  <a:pt x="416" y="92"/>
                </a:lnTo>
                <a:lnTo>
                  <a:pt x="1252" y="92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73"/>
          <p:cNvSpPr/>
          <p:nvPr/>
        </p:nvSpPr>
        <p:spPr>
          <a:xfrm>
            <a:off x="1479600" y="4233960"/>
            <a:ext cx="1938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tage III (n=24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27"/>
          <p:cNvSpPr/>
          <p:nvPr/>
        </p:nvSpPr>
        <p:spPr>
          <a:xfrm>
            <a:off x="4462560" y="4987800"/>
            <a:ext cx="88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=0.18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17"/>
          <p:cNvSpPr/>
          <p:nvPr/>
        </p:nvSpPr>
        <p:spPr>
          <a:xfrm>
            <a:off x="4118040" y="6541920"/>
            <a:ext cx="1468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Years after surger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18"/>
          <p:cNvSpPr/>
          <p:nvPr/>
        </p:nvSpPr>
        <p:spPr>
          <a:xfrm>
            <a:off x="6053760" y="637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19"/>
          <p:cNvSpPr/>
          <p:nvPr/>
        </p:nvSpPr>
        <p:spPr>
          <a:xfrm>
            <a:off x="5639400" y="637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20"/>
          <p:cNvSpPr/>
          <p:nvPr/>
        </p:nvSpPr>
        <p:spPr>
          <a:xfrm>
            <a:off x="5214960" y="637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21"/>
          <p:cNvSpPr/>
          <p:nvPr/>
        </p:nvSpPr>
        <p:spPr>
          <a:xfrm>
            <a:off x="4803840" y="637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22"/>
          <p:cNvSpPr/>
          <p:nvPr/>
        </p:nvSpPr>
        <p:spPr>
          <a:xfrm>
            <a:off x="4389480" y="637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23"/>
          <p:cNvSpPr/>
          <p:nvPr/>
        </p:nvSpPr>
        <p:spPr>
          <a:xfrm>
            <a:off x="3957480" y="637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124"/>
          <p:cNvSpPr/>
          <p:nvPr/>
        </p:nvSpPr>
        <p:spPr>
          <a:xfrm>
            <a:off x="3472560" y="6377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26"/>
          <p:cNvSpPr/>
          <p:nvPr/>
        </p:nvSpPr>
        <p:spPr>
          <a:xfrm>
            <a:off x="3344040" y="43513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27"/>
          <p:cNvSpPr/>
          <p:nvPr/>
        </p:nvSpPr>
        <p:spPr>
          <a:xfrm>
            <a:off x="3415680" y="473220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128"/>
          <p:cNvSpPr/>
          <p:nvPr/>
        </p:nvSpPr>
        <p:spPr>
          <a:xfrm>
            <a:off x="3426480" y="511020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29"/>
          <p:cNvSpPr/>
          <p:nvPr/>
        </p:nvSpPr>
        <p:spPr>
          <a:xfrm>
            <a:off x="3420360" y="549108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30"/>
          <p:cNvSpPr/>
          <p:nvPr/>
        </p:nvSpPr>
        <p:spPr>
          <a:xfrm>
            <a:off x="3420360" y="5872320"/>
            <a:ext cx="128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138"/>
          <p:cNvSpPr/>
          <p:nvPr/>
        </p:nvSpPr>
        <p:spPr>
          <a:xfrm>
            <a:off x="3589200" y="6338880"/>
            <a:ext cx="2503800" cy="12600"/>
          </a:xfrm>
          <a:custGeom>
            <a:avLst/>
            <a:gdLst>
              <a:gd name="textAreaLeft" fmla="*/ 0 w 2503800"/>
              <a:gd name="textAreaRight" fmla="*/ 2504160 w 2503800"/>
              <a:gd name="textAreaTop" fmla="*/ 0 h 12600"/>
              <a:gd name="textAreaBottom" fmla="*/ 12960 h 12600"/>
            </a:gdLst>
            <a:ahLst/>
            <a:rect l="textAreaLeft" t="textAreaTop" r="textAreaRight" b="textAreaBottom"/>
            <a:pathLst>
              <a:path w="1545" h="8">
                <a:moveTo>
                  <a:pt x="1545" y="0"/>
                </a:moveTo>
                <a:lnTo>
                  <a:pt x="1545" y="8"/>
                </a:lnTo>
                <a:moveTo>
                  <a:pt x="1289" y="0"/>
                </a:moveTo>
                <a:lnTo>
                  <a:pt x="1289" y="8"/>
                </a:lnTo>
                <a:moveTo>
                  <a:pt x="1029" y="0"/>
                </a:moveTo>
                <a:lnTo>
                  <a:pt x="1029" y="8"/>
                </a:lnTo>
                <a:moveTo>
                  <a:pt x="773" y="0"/>
                </a:moveTo>
                <a:lnTo>
                  <a:pt x="773" y="8"/>
                </a:lnTo>
                <a:moveTo>
                  <a:pt x="516" y="0"/>
                </a:moveTo>
                <a:lnTo>
                  <a:pt x="516" y="8"/>
                </a:lnTo>
                <a:moveTo>
                  <a:pt x="256" y="0"/>
                </a:moveTo>
                <a:lnTo>
                  <a:pt x="256" y="8"/>
                </a:lnTo>
                <a:moveTo>
                  <a:pt x="0" y="0"/>
                </a:moveTo>
                <a:lnTo>
                  <a:pt x="0" y="8"/>
                </a:lnTo>
              </a:path>
            </a:pathLst>
          </a:cu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139"/>
          <p:cNvSpPr/>
          <p:nvPr/>
        </p:nvSpPr>
        <p:spPr>
          <a:xfrm>
            <a:off x="3568680" y="4443480"/>
            <a:ext cx="20520" cy="1888920"/>
          </a:xfrm>
          <a:custGeom>
            <a:avLst/>
            <a:gdLst>
              <a:gd name="textAreaLeft" fmla="*/ 0 w 20520"/>
              <a:gd name="textAreaRight" fmla="*/ 20880 w 20520"/>
              <a:gd name="textAreaTop" fmla="*/ 0 h 1888920"/>
              <a:gd name="textAreaBottom" fmla="*/ 1889280 h 1888920"/>
            </a:gdLst>
            <a:ahLst/>
            <a:rect l="textAreaLeft" t="textAreaTop" r="textAreaRight" b="textAreaBottom"/>
            <a:pathLst>
              <a:path w="13" h="1242">
                <a:moveTo>
                  <a:pt x="0" y="0"/>
                </a:moveTo>
                <a:lnTo>
                  <a:pt x="13" y="0"/>
                </a:lnTo>
                <a:moveTo>
                  <a:pt x="0" y="247"/>
                </a:moveTo>
                <a:lnTo>
                  <a:pt x="13" y="247"/>
                </a:lnTo>
                <a:moveTo>
                  <a:pt x="0" y="495"/>
                </a:moveTo>
                <a:lnTo>
                  <a:pt x="13" y="495"/>
                </a:lnTo>
                <a:moveTo>
                  <a:pt x="0" y="747"/>
                </a:moveTo>
                <a:lnTo>
                  <a:pt x="13" y="747"/>
                </a:lnTo>
                <a:moveTo>
                  <a:pt x="0" y="995"/>
                </a:moveTo>
                <a:lnTo>
                  <a:pt x="13" y="995"/>
                </a:lnTo>
                <a:moveTo>
                  <a:pt x="0" y="1242"/>
                </a:moveTo>
                <a:lnTo>
                  <a:pt x="13" y="1242"/>
                </a:lnTo>
              </a:path>
            </a:pathLst>
          </a:custGeom>
          <a:noFill/>
          <a:ln w="20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142"/>
          <p:cNvSpPr/>
          <p:nvPr/>
        </p:nvSpPr>
        <p:spPr>
          <a:xfrm>
            <a:off x="3589200" y="6332400"/>
            <a:ext cx="25038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143"/>
          <p:cNvSpPr/>
          <p:nvPr/>
        </p:nvSpPr>
        <p:spPr>
          <a:xfrm flipV="1">
            <a:off x="3589200" y="4443120"/>
            <a:ext cx="0" cy="1888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181"/>
          <p:cNvSpPr/>
          <p:nvPr/>
        </p:nvSpPr>
        <p:spPr>
          <a:xfrm rot="16200000">
            <a:off x="2549880" y="5300640"/>
            <a:ext cx="1465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verall survival r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167"/>
          <p:cNvSpPr/>
          <p:nvPr/>
        </p:nvSpPr>
        <p:spPr>
          <a:xfrm>
            <a:off x="3643200" y="4457880"/>
            <a:ext cx="1567080" cy="1876320"/>
          </a:xfrm>
          <a:custGeom>
            <a:avLst/>
            <a:gdLst>
              <a:gd name="textAreaLeft" fmla="*/ 0 w 1567080"/>
              <a:gd name="textAreaRight" fmla="*/ 1567440 w 1567080"/>
              <a:gd name="textAreaTop" fmla="*/ 0 h 1876320"/>
              <a:gd name="textAreaBottom" fmla="*/ 1876680 h 1876320"/>
            </a:gdLst>
            <a:ahLst/>
            <a:rect l="textAreaLeft" t="textAreaTop" r="textAreaRight" b="textAreaBottom"/>
            <a:pathLst>
              <a:path w="987" h="1182">
                <a:moveTo>
                  <a:pt x="0" y="0"/>
                </a:moveTo>
                <a:lnTo>
                  <a:pt x="0" y="132"/>
                </a:lnTo>
                <a:lnTo>
                  <a:pt x="90" y="132"/>
                </a:lnTo>
                <a:lnTo>
                  <a:pt x="90" y="282"/>
                </a:lnTo>
                <a:lnTo>
                  <a:pt x="537" y="282"/>
                </a:lnTo>
                <a:lnTo>
                  <a:pt x="537" y="513"/>
                </a:lnTo>
                <a:lnTo>
                  <a:pt x="987" y="513"/>
                </a:lnTo>
                <a:lnTo>
                  <a:pt x="987" y="1182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168"/>
          <p:cNvSpPr/>
          <p:nvPr/>
        </p:nvSpPr>
        <p:spPr>
          <a:xfrm>
            <a:off x="3624120" y="4448160"/>
            <a:ext cx="2352960" cy="1328760"/>
          </a:xfrm>
          <a:custGeom>
            <a:avLst/>
            <a:gdLst>
              <a:gd name="textAreaLeft" fmla="*/ 0 w 2352960"/>
              <a:gd name="textAreaRight" fmla="*/ 2353320 w 2352960"/>
              <a:gd name="textAreaTop" fmla="*/ 0 h 1328760"/>
              <a:gd name="textAreaBottom" fmla="*/ 1329120 h 1328760"/>
            </a:gdLst>
            <a:ahLst/>
            <a:rect l="textAreaLeft" t="textAreaTop" r="textAreaRight" b="textAreaBottom"/>
            <a:pathLst>
              <a:path w="1482" h="837">
                <a:moveTo>
                  <a:pt x="0" y="0"/>
                </a:moveTo>
                <a:lnTo>
                  <a:pt x="51" y="0"/>
                </a:lnTo>
                <a:lnTo>
                  <a:pt x="51" y="72"/>
                </a:lnTo>
                <a:lnTo>
                  <a:pt x="282" y="72"/>
                </a:lnTo>
                <a:lnTo>
                  <a:pt x="282" y="150"/>
                </a:lnTo>
                <a:lnTo>
                  <a:pt x="399" y="150"/>
                </a:lnTo>
                <a:lnTo>
                  <a:pt x="399" y="237"/>
                </a:lnTo>
                <a:lnTo>
                  <a:pt x="900" y="237"/>
                </a:lnTo>
                <a:lnTo>
                  <a:pt x="900" y="357"/>
                </a:lnTo>
                <a:lnTo>
                  <a:pt x="1041" y="357"/>
                </a:lnTo>
                <a:lnTo>
                  <a:pt x="1041" y="498"/>
                </a:lnTo>
                <a:lnTo>
                  <a:pt x="1341" y="498"/>
                </a:lnTo>
                <a:lnTo>
                  <a:pt x="1341" y="837"/>
                </a:lnTo>
                <a:lnTo>
                  <a:pt x="1482" y="837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121"/>
          <p:cNvSpPr/>
          <p:nvPr/>
        </p:nvSpPr>
        <p:spPr>
          <a:xfrm>
            <a:off x="3341520" y="1600200"/>
            <a:ext cx="307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rgery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djuvant therapy (n=3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124"/>
          <p:cNvSpPr/>
          <p:nvPr/>
        </p:nvSpPr>
        <p:spPr>
          <a:xfrm>
            <a:off x="3740040" y="2590920"/>
            <a:ext cx="18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rgery alone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n=2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121"/>
          <p:cNvSpPr/>
          <p:nvPr/>
        </p:nvSpPr>
        <p:spPr>
          <a:xfrm>
            <a:off x="3613320" y="4276800"/>
            <a:ext cx="295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rgery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adjuvant therapy (n=1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124"/>
          <p:cNvSpPr/>
          <p:nvPr/>
        </p:nvSpPr>
        <p:spPr>
          <a:xfrm>
            <a:off x="3621240" y="5305320"/>
            <a:ext cx="18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rgery alone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n=9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64"/>
          <p:cNvSpPr/>
          <p:nvPr/>
        </p:nvSpPr>
        <p:spPr>
          <a:xfrm>
            <a:off x="1157400" y="1468440"/>
            <a:ext cx="43632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64"/>
          <p:cNvSpPr/>
          <p:nvPr/>
        </p:nvSpPr>
        <p:spPr>
          <a:xfrm>
            <a:off x="1247760" y="4076640"/>
            <a:ext cx="399960" cy="398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03120" y="871560"/>
            <a:ext cx="8593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Overall survival of patients at stage I and III according to receipt of adjuvant therapy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8T09:00:45Z</dcterms:created>
  <dc:creator>s.kashiwagi</dc:creator>
  <dc:description/>
  <dc:language>en-US</dc:language>
  <cp:lastModifiedBy>Yashiro</cp:lastModifiedBy>
  <cp:lastPrinted>2010-08-12T06:15:14Z</cp:lastPrinted>
  <dcterms:modified xsi:type="dcterms:W3CDTF">2011-11-26T14:56:59Z</dcterms:modified>
  <cp:revision>195</cp:revision>
  <dc:subject/>
  <dc:title>スライド 1</dc:title>
</cp:coreProperties>
</file>